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10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5.jpeg" ContentType="image/jpeg"/>
  <Override PartName="/ppt/media/image6.jpeg" ContentType="image/jpeg"/>
  <Override PartName="/ppt/media/image8.png" ContentType="image/png"/>
  <Override PartName="/ppt/media/image7.jpeg" ContentType="image/jpeg"/>
  <Override PartName="/ppt/media/image11.png" ContentType="image/png"/>
  <Override PartName="/ppt/media/image9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34EA49-DFC0-47EF-8FD5-D3DDE46BDD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AD84D-488A-4A3A-BFB5-40C100F83A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BE5CF-FAFC-4626-A176-B688B69177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BDCA0-7640-464C-8068-06D38457EA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390D13-1AC6-4D56-8708-1EC266CF9A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4FDBBD-4E18-4304-8311-2DCDA48A95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4C653-8200-4F25-BFD5-2495B241F1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1A4E8-EC1B-4B42-9F72-B41985CC2F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F6713-A811-473A-A7A3-7CEB446A1B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D5097-095A-41B8-8822-5A0BF47B69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09649E-7863-4DCE-8B59-BE4D08204F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571CB-8E5D-4126-9EF6-FD949EB859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D121DF-A8B1-4DDE-BF48-8863E3F5A3E7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4" Type="http://schemas.openxmlformats.org/officeDocument/2006/relationships/oleObject" Target="../embeddings/oleObject2.bin"/><Relationship Id="rId5" Type="http://schemas.openxmlformats.org/officeDocument/2006/relationships/image" Target="../media/image3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image" Target="../media/image5.jpeg"/><Relationship Id="rId3" Type="http://schemas.openxmlformats.org/officeDocument/2006/relationships/image" Target="../media/image6.jpeg"/><Relationship Id="rId4" Type="http://schemas.openxmlformats.org/officeDocument/2006/relationships/image" Target="../media/image7.jpeg"/><Relationship Id="rId5" Type="http://schemas.openxmlformats.org/officeDocument/2006/relationships/oleObject" Target="../embeddings/oleObject1.bin"/><Relationship Id="rId6" Type="http://schemas.openxmlformats.org/officeDocument/2006/relationships/image" Target="../media/image8.png"/><Relationship Id="rId7" Type="http://schemas.openxmlformats.org/officeDocument/2006/relationships/oleObject" Target="../embeddings/oleObject2.bin"/><Relationship Id="rId8" Type="http://schemas.openxmlformats.org/officeDocument/2006/relationships/image" Target="../media/image9.png"/><Relationship Id="rId9" Type="http://schemas.openxmlformats.org/officeDocument/2006/relationships/oleObject" Target="../embeddings/oleObject3.bin"/><Relationship Id="rId10" Type="http://schemas.openxmlformats.org/officeDocument/2006/relationships/image" Target="../media/image10.png"/><Relationship Id="rId11" Type="http://schemas.openxmlformats.org/officeDocument/2006/relationships/oleObject" Target="../embeddings/oleObject4.bin"/><Relationship Id="rId12" Type="http://schemas.openxmlformats.org/officeDocument/2006/relationships/image" Target="../media/image11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241880" y="3008160"/>
            <a:ext cx="479520" cy="11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4263120" y="3027240"/>
            <a:ext cx="1111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aline-treated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241880" y="3173400"/>
            <a:ext cx="631800" cy="11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255560" y="3260880"/>
            <a:ext cx="1498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driamycin-treated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3860640" y="3286080"/>
            <a:ext cx="281160" cy="166680"/>
          </a:xfrm>
          <a:prstGeom prst="rect">
            <a:avLst/>
          </a:prstGeom>
          <a:solidFill>
            <a:srgbClr val="60a8e8"/>
          </a:solidFill>
          <a:ln w="9360">
            <a:solidFill>
              <a:srgbClr val="60a8e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860640" y="3041640"/>
            <a:ext cx="281160" cy="166680"/>
          </a:xfrm>
          <a:prstGeom prst="rect">
            <a:avLst/>
          </a:prstGeom>
          <a:solidFill>
            <a:srgbClr val="e880b8"/>
          </a:solidFill>
          <a:ln w="9360">
            <a:solidFill>
              <a:srgbClr val="e880b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644480" y="3778200"/>
            <a:ext cx="2718000" cy="3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 flipV="1">
            <a:off x="1644480" y="1485720"/>
            <a:ext cx="1800" cy="2197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1611360" y="3083040"/>
            <a:ext cx="33120" cy="3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1611360" y="2550960"/>
            <a:ext cx="33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1611360" y="2017800"/>
            <a:ext cx="33120" cy="3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1396800" y="348768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1396800" y="295416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1396800" y="242244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1396800" y="189072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1396800" y="136224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2222640" y="2895480"/>
            <a:ext cx="39600" cy="3996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2222640" y="2793960"/>
            <a:ext cx="39600" cy="3960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720" bIns="-18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2222640" y="2793960"/>
            <a:ext cx="39600" cy="3960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720" bIns="-18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2222640" y="1835280"/>
            <a:ext cx="39600" cy="410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2222640" y="1886040"/>
            <a:ext cx="39600" cy="3960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720" bIns="-18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2222640" y="1938240"/>
            <a:ext cx="39600" cy="3816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9440" bIns="-19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2222640" y="1886040"/>
            <a:ext cx="39600" cy="3960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720" bIns="-18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2066760" y="2523960"/>
            <a:ext cx="365400" cy="187560"/>
          </a:xfrm>
          <a:prstGeom prst="rect">
            <a:avLst/>
          </a:prstGeom>
          <a:solidFill>
            <a:srgbClr val="e880b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2066760" y="2657520"/>
            <a:ext cx="365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2251080" y="2711520"/>
            <a:ext cx="0" cy="52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2189160" y="2763720"/>
            <a:ext cx="1206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 flipV="1">
            <a:off x="2251080" y="2095560"/>
            <a:ext cx="0" cy="428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2189160" y="2095560"/>
            <a:ext cx="1206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2825640" y="3166920"/>
            <a:ext cx="42840" cy="4140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2825640" y="3166920"/>
            <a:ext cx="42840" cy="4140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2825640" y="3005280"/>
            <a:ext cx="42840" cy="3960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720" bIns="-18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2825640" y="2944800"/>
            <a:ext cx="42840" cy="5076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2825640" y="2944800"/>
            <a:ext cx="42840" cy="5076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2825640" y="2944800"/>
            <a:ext cx="42840" cy="5076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2825640" y="1835280"/>
            <a:ext cx="42840" cy="410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2825640" y="1835280"/>
            <a:ext cx="42840" cy="410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2825640" y="1996920"/>
            <a:ext cx="42840" cy="428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2825640" y="2046240"/>
            <a:ext cx="42840" cy="428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2825640" y="1996920"/>
            <a:ext cx="42840" cy="428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2673360" y="2657520"/>
            <a:ext cx="365040" cy="106200"/>
          </a:xfrm>
          <a:prstGeom prst="rect">
            <a:avLst/>
          </a:prstGeom>
          <a:solidFill>
            <a:srgbClr val="60a8e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2673360" y="2711520"/>
            <a:ext cx="365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2854440" y="2763720"/>
            <a:ext cx="3240" cy="149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2795760" y="2913120"/>
            <a:ext cx="120600" cy="3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2854440" y="2550960"/>
            <a:ext cx="3240" cy="106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2795760" y="2550960"/>
            <a:ext cx="1206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3432240" y="2419200"/>
            <a:ext cx="52200" cy="428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3432240" y="2360520"/>
            <a:ext cx="52200" cy="5076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3432240" y="2360520"/>
            <a:ext cx="52200" cy="5076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3432240" y="2309760"/>
            <a:ext cx="52200" cy="4140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3432240" y="1776240"/>
            <a:ext cx="52200" cy="5112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3432240" y="1776240"/>
            <a:ext cx="52200" cy="5112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3432240" y="1835280"/>
            <a:ext cx="52200" cy="410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3279600" y="1967040"/>
            <a:ext cx="363600" cy="158760"/>
          </a:xfrm>
          <a:prstGeom prst="rect">
            <a:avLst/>
          </a:prstGeom>
          <a:solidFill>
            <a:srgbClr val="e880b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3279600" y="2071800"/>
            <a:ext cx="363600" cy="3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3460680" y="2125800"/>
            <a:ext cx="1800" cy="139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3402000" y="2265480"/>
            <a:ext cx="122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 flipV="1">
            <a:off x="3460680" y="1913040"/>
            <a:ext cx="1800" cy="54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3402000" y="1913040"/>
            <a:ext cx="122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4048200" y="2471760"/>
            <a:ext cx="38160" cy="3960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720" bIns="-18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4048200" y="2419200"/>
            <a:ext cx="38160" cy="428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6200" bIns="-16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4048200" y="2360520"/>
            <a:ext cx="38160" cy="5076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4048200" y="2360520"/>
            <a:ext cx="38160" cy="5076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4048200" y="2360520"/>
            <a:ext cx="38160" cy="5076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4048200" y="1727280"/>
            <a:ext cx="38160" cy="3960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720" bIns="-18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4048200" y="1776240"/>
            <a:ext cx="38160" cy="5112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4048200" y="1776240"/>
            <a:ext cx="38160" cy="5112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4048200" y="1776240"/>
            <a:ext cx="38160" cy="5112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4048200" y="1776240"/>
            <a:ext cx="38160" cy="5112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4048200" y="1835280"/>
            <a:ext cx="38160" cy="410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4048200" y="1776240"/>
            <a:ext cx="38160" cy="5112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4048200" y="1835280"/>
            <a:ext cx="38160" cy="410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4048200" y="1835280"/>
            <a:ext cx="38160" cy="41040"/>
          </a:xfrm>
          <a:prstGeom prst="ellipse">
            <a:avLst/>
          </a:prstGeom>
          <a:solidFill>
            <a:srgbClr val="000000"/>
          </a:solidFill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7280" bIns="-17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3886200" y="1967040"/>
            <a:ext cx="363600" cy="210960"/>
          </a:xfrm>
          <a:prstGeom prst="rect">
            <a:avLst/>
          </a:prstGeom>
          <a:solidFill>
            <a:srgbClr val="60a8e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3886200" y="2071800"/>
            <a:ext cx="363600" cy="3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4067280" y="2178000"/>
            <a:ext cx="1440" cy="162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4005360" y="2340000"/>
            <a:ext cx="125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 flipV="1">
            <a:off x="4067280" y="1902960"/>
            <a:ext cx="1440" cy="63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4005360" y="1903320"/>
            <a:ext cx="1252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2314440" y="3724200"/>
            <a:ext cx="471600" cy="29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2347200" y="3879720"/>
            <a:ext cx="40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10.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3530520" y="3724200"/>
            <a:ext cx="473040" cy="29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3560040" y="3879720"/>
            <a:ext cx="401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11.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2394000" y="1362240"/>
            <a:ext cx="352440" cy="4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3300480" y="1512720"/>
            <a:ext cx="915840" cy="23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1611360" y="3610080"/>
            <a:ext cx="33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1644480" y="3733920"/>
            <a:ext cx="1800" cy="54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1619280" y="3625560"/>
            <a:ext cx="10944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 flipV="1">
            <a:off x="1611360" y="3670200"/>
            <a:ext cx="111240" cy="92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 rot="16200000">
            <a:off x="465480" y="2384640"/>
            <a:ext cx="1360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omite number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2116080" y="3819600"/>
            <a:ext cx="957240" cy="0"/>
          </a:xfrm>
          <a:prstGeom prst="line">
            <a:avLst/>
          </a:prstGeom>
          <a:ln w="19080">
            <a:solidFill>
              <a:srgbClr val="3366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3284640" y="3819600"/>
            <a:ext cx="957240" cy="0"/>
          </a:xfrm>
          <a:prstGeom prst="line">
            <a:avLst/>
          </a:prstGeom>
          <a:ln w="19080">
            <a:solidFill>
              <a:srgbClr val="3366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960480" y="4761000"/>
            <a:ext cx="51325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. 1 – Effect of Adriamycin exposure on embryo developmen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Box plot showing somite numbers for E10.5 and E11.5 CBA/Ca embryos treated with Adriamycin or saline. Somite numbers do not differ between the two groups (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&gt; 0.05) indicating no significant effect of Adriamycin treatment on developmental progression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4" name="" descr=""/>
          <p:cNvPicPr/>
          <p:nvPr/>
        </p:nvPicPr>
        <p:blipFill>
          <a:blip r:embed="rId1"/>
          <a:srcRect l="0" t="0" r="0" b="1518"/>
          <a:stretch/>
        </p:blipFill>
        <p:spPr>
          <a:xfrm>
            <a:off x="2421000" y="623880"/>
            <a:ext cx="1903320" cy="2023920"/>
          </a:xfrm>
          <a:prstGeom prst="rect">
            <a:avLst/>
          </a:prstGeom>
          <a:ln w="0">
            <a:noFill/>
          </a:ln>
        </p:spPr>
      </p:pic>
      <p:sp>
        <p:nvSpPr>
          <p:cNvPr id="135" name=""/>
          <p:cNvSpPr/>
          <p:nvPr/>
        </p:nvSpPr>
        <p:spPr>
          <a:xfrm>
            <a:off x="3210120" y="1496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3431160" y="174312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LI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 flipH="1">
            <a:off x="3571560" y="1009800"/>
            <a:ext cx="152280" cy="0"/>
          </a:xfrm>
          <a:prstGeom prst="line">
            <a:avLst/>
          </a:prstGeom>
          <a:ln w="2556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2421000" y="631800"/>
            <a:ext cx="268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3789360" y="584280"/>
            <a:ext cx="77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E10.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1559160" y="2720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141" name=""/>
          <p:cNvGraphicFramePr/>
          <p:nvPr/>
        </p:nvGraphicFramePr>
        <p:xfrm>
          <a:off x="2036880" y="2871720"/>
          <a:ext cx="2760480" cy="208116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142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2036880" y="2871720"/>
                    <a:ext cx="2760480" cy="2081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43" name=""/>
          <p:cNvGraphicFramePr/>
          <p:nvPr/>
        </p:nvGraphicFramePr>
        <p:xfrm>
          <a:off x="1989000" y="5032440"/>
          <a:ext cx="2752920" cy="208116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144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1989000" y="5032440"/>
                    <a:ext cx="2752920" cy="2081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5" name=""/>
          <p:cNvSpPr/>
          <p:nvPr/>
        </p:nvSpPr>
        <p:spPr>
          <a:xfrm>
            <a:off x="1559160" y="4881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2735280" y="6770520"/>
            <a:ext cx="725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3668760" y="6770520"/>
            <a:ext cx="725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2732760" y="5097600"/>
            <a:ext cx="1527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ole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hh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+/+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hh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+/-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hh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2517840" y="5208480"/>
            <a:ext cx="193680" cy="69840"/>
          </a:xfrm>
          <a:prstGeom prst="rect">
            <a:avLst/>
          </a:prstGeom>
          <a:solidFill>
            <a:srgbClr val="008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2517840" y="5348160"/>
            <a:ext cx="193680" cy="6984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2661120" y="2865600"/>
            <a:ext cx="1527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ole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hh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+/+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hh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+/-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hh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2471760" y="2973240"/>
            <a:ext cx="192240" cy="69840"/>
          </a:xfrm>
          <a:prstGeom prst="rect">
            <a:avLst/>
          </a:prstGeom>
          <a:solidFill>
            <a:srgbClr val="008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2471760" y="3112920"/>
            <a:ext cx="192240" cy="6984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3751200" y="2576520"/>
            <a:ext cx="3142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55" name=""/>
          <p:cNvGrpSpPr/>
          <p:nvPr/>
        </p:nvGrpSpPr>
        <p:grpSpPr>
          <a:xfrm>
            <a:off x="2738520" y="4610160"/>
            <a:ext cx="1657080" cy="0"/>
            <a:chOff x="2738520" y="4610160"/>
            <a:chExt cx="1657080" cy="0"/>
          </a:xfrm>
        </p:grpSpPr>
        <p:sp>
          <p:nvSpPr>
            <p:cNvPr id="156" name=""/>
            <p:cNvSpPr/>
            <p:nvPr/>
          </p:nvSpPr>
          <p:spPr>
            <a:xfrm>
              <a:off x="2738520" y="4610160"/>
              <a:ext cx="72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3671280" y="4610160"/>
              <a:ext cx="72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58" name=""/>
          <p:cNvSpPr/>
          <p:nvPr/>
        </p:nvSpPr>
        <p:spPr>
          <a:xfrm>
            <a:off x="907920" y="7905600"/>
            <a:ext cx="52038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Supplementary Fig. 2 – Growth and development of </a:t>
            </a:r>
            <a:r>
              <a:rPr b="1" i="1" lang="en-GB" sz="1200" spc="-1" strike="noStrike">
                <a:solidFill>
                  <a:srgbClr val="000000"/>
                </a:solidFill>
                <a:latin typeface="Times New Roman"/>
              </a:rPr>
              <a:t>Shh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null embryo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(A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E10.5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hh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null embryo showing forebrain (arrow), heart (H) and limb (LI) abnormalities.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(B,C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Box plots showing that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hh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null embryos have significantly smaller crown-rump lengths than normal littermates (B;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p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lt; 0.0001) whereas there are no significant differences in somite number between genotypes at either E10.5 or E11.5 (C;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p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&gt; 0.05). Scale bar in (A): 1 mm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9" name=""/>
          <p:cNvGrpSpPr/>
          <p:nvPr/>
        </p:nvGrpSpPr>
        <p:grpSpPr>
          <a:xfrm>
            <a:off x="767160" y="488880"/>
            <a:ext cx="5327280" cy="7109280"/>
            <a:chOff x="767160" y="488880"/>
            <a:chExt cx="5327280" cy="7109280"/>
          </a:xfrm>
        </p:grpSpPr>
        <p:pic>
          <p:nvPicPr>
            <p:cNvPr id="160" name="" descr=""/>
            <p:cNvPicPr/>
            <p:nvPr/>
          </p:nvPicPr>
          <p:blipFill>
            <a:blip r:embed="rId1">
              <a:lum bright="6000"/>
            </a:blip>
            <a:srcRect l="27121" t="18801" r="30386" b="19022"/>
            <a:stretch/>
          </p:blipFill>
          <p:spPr>
            <a:xfrm>
              <a:off x="1676520" y="4037040"/>
              <a:ext cx="826920" cy="10065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61" name=""/>
            <p:cNvGrpSpPr/>
            <p:nvPr/>
          </p:nvGrpSpPr>
          <p:grpSpPr>
            <a:xfrm>
              <a:off x="908280" y="771480"/>
              <a:ext cx="660240" cy="1458720"/>
              <a:chOff x="908280" y="771480"/>
              <a:chExt cx="660240" cy="1458720"/>
            </a:xfrm>
          </p:grpSpPr>
          <p:sp>
            <p:nvSpPr>
              <p:cNvPr id="162" name=""/>
              <p:cNvSpPr/>
              <p:nvPr/>
            </p:nvSpPr>
            <p:spPr>
              <a:xfrm>
                <a:off x="1038240" y="969840"/>
                <a:ext cx="149040" cy="1077120"/>
              </a:xfrm>
              <a:custGeom>
                <a:avLst/>
                <a:gdLst/>
                <a:ahLst/>
                <a:rect l="l" t="t" r="r" b="b"/>
                <a:pathLst>
                  <a:path w="256" h="1496">
                    <a:moveTo>
                      <a:pt x="56" y="48"/>
                    </a:moveTo>
                    <a:cubicBezTo>
                      <a:pt x="76" y="24"/>
                      <a:pt x="96" y="0"/>
                      <a:pt x="104" y="192"/>
                    </a:cubicBezTo>
                    <a:cubicBezTo>
                      <a:pt x="112" y="384"/>
                      <a:pt x="120" y="1000"/>
                      <a:pt x="104" y="1200"/>
                    </a:cubicBezTo>
                    <a:cubicBezTo>
                      <a:pt x="88" y="1400"/>
                      <a:pt x="16" y="1352"/>
                      <a:pt x="8" y="1392"/>
                    </a:cubicBezTo>
                    <a:cubicBezTo>
                      <a:pt x="0" y="1432"/>
                      <a:pt x="32" y="1440"/>
                      <a:pt x="56" y="1440"/>
                    </a:cubicBezTo>
                    <a:cubicBezTo>
                      <a:pt x="80" y="1440"/>
                      <a:pt x="136" y="1392"/>
                      <a:pt x="152" y="1392"/>
                    </a:cubicBezTo>
                    <a:cubicBezTo>
                      <a:pt x="168" y="1392"/>
                      <a:pt x="144" y="1424"/>
                      <a:pt x="152" y="1440"/>
                    </a:cubicBezTo>
                    <a:cubicBezTo>
                      <a:pt x="160" y="1456"/>
                      <a:pt x="184" y="1496"/>
                      <a:pt x="200" y="1488"/>
                    </a:cubicBezTo>
                    <a:cubicBezTo>
                      <a:pt x="216" y="1480"/>
                      <a:pt x="240" y="1416"/>
                      <a:pt x="248" y="1392"/>
                    </a:cubicBezTo>
                    <a:cubicBezTo>
                      <a:pt x="256" y="1368"/>
                      <a:pt x="252" y="1356"/>
                      <a:pt x="248" y="1344"/>
                    </a:cubicBez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1099080" y="2005560"/>
                <a:ext cx="27720" cy="104040"/>
              </a:xfrm>
              <a:custGeom>
                <a:avLst/>
                <a:gdLst/>
                <a:ahLst/>
                <a:rect l="l" t="t" r="r" b="b"/>
                <a:pathLst>
                  <a:path w="1" h="336">
                    <a:moveTo>
                      <a:pt x="0" y="0"/>
                    </a:moveTo>
                    <a:cubicBezTo>
                      <a:pt x="0" y="92"/>
                      <a:pt x="0" y="184"/>
                      <a:pt x="0" y="240"/>
                    </a:cubicBezTo>
                    <a:cubicBezTo>
                      <a:pt x="0" y="296"/>
                      <a:pt x="0" y="316"/>
                      <a:pt x="0" y="336"/>
                    </a:cubicBezTo>
                  </a:path>
                </a:pathLst>
              </a:custGeom>
              <a:solidFill>
                <a:srgbClr val="dddddd"/>
              </a:solidFill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1207080" y="1004400"/>
                <a:ext cx="31680" cy="1070640"/>
              </a:xfrm>
              <a:custGeom>
                <a:avLst/>
                <a:gdLst/>
                <a:ahLst/>
                <a:rect l="l" t="t" r="r" b="b"/>
                <a:pathLst>
                  <a:path w="56" h="1488">
                    <a:moveTo>
                      <a:pt x="56" y="0"/>
                    </a:moveTo>
                    <a:cubicBezTo>
                      <a:pt x="36" y="60"/>
                      <a:pt x="16" y="120"/>
                      <a:pt x="8" y="336"/>
                    </a:cubicBezTo>
                    <a:cubicBezTo>
                      <a:pt x="0" y="552"/>
                      <a:pt x="8" y="1104"/>
                      <a:pt x="8" y="1296"/>
                    </a:cubicBezTo>
                    <a:cubicBezTo>
                      <a:pt x="8" y="1488"/>
                      <a:pt x="8" y="1456"/>
                      <a:pt x="8" y="1488"/>
                    </a:cubicBezTo>
                  </a:path>
                </a:pathLst>
              </a:custGeom>
              <a:solidFill>
                <a:srgbClr val="ccffff"/>
              </a:solidFill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1004040" y="1026360"/>
                <a:ext cx="306000" cy="0"/>
              </a:xfrm>
              <a:prstGeom prst="line">
                <a:avLst/>
              </a:prstGeom>
              <a:ln w="12600">
                <a:solidFill>
                  <a:srgbClr val="3366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1052640" y="1454040"/>
                <a:ext cx="320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o</a:t>
                </a:r>
                <a:endParaRPr b="0" lang="en-US" sz="9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908280" y="1983960"/>
                <a:ext cx="336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b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1247760" y="96084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1247760" y="128304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2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1247760" y="158688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3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1247760" y="192708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1004040" y="1337040"/>
                <a:ext cx="304200" cy="0"/>
              </a:xfrm>
              <a:prstGeom prst="line">
                <a:avLst/>
              </a:prstGeom>
              <a:ln w="12600">
                <a:solidFill>
                  <a:srgbClr val="3366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1004040" y="1648800"/>
                <a:ext cx="306000" cy="0"/>
              </a:xfrm>
              <a:prstGeom prst="line">
                <a:avLst/>
              </a:prstGeom>
              <a:ln w="12600">
                <a:solidFill>
                  <a:srgbClr val="3366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1004040" y="1981080"/>
                <a:ext cx="306000" cy="0"/>
              </a:xfrm>
              <a:prstGeom prst="line">
                <a:avLst/>
              </a:prstGeom>
              <a:ln w="12600">
                <a:solidFill>
                  <a:srgbClr val="0099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914760" y="771480"/>
                <a:ext cx="646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10.5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76" name=""/>
            <p:cNvGrpSpPr/>
            <p:nvPr/>
          </p:nvGrpSpPr>
          <p:grpSpPr>
            <a:xfrm>
              <a:off x="767160" y="2816280"/>
              <a:ext cx="866160" cy="2333520"/>
              <a:chOff x="767160" y="2816280"/>
              <a:chExt cx="866160" cy="2333520"/>
            </a:xfrm>
          </p:grpSpPr>
          <p:sp>
            <p:nvSpPr>
              <p:cNvPr id="177" name=""/>
              <p:cNvSpPr/>
              <p:nvPr/>
            </p:nvSpPr>
            <p:spPr>
              <a:xfrm>
                <a:off x="828000" y="3080160"/>
                <a:ext cx="510840" cy="0"/>
              </a:xfrm>
              <a:prstGeom prst="line">
                <a:avLst/>
              </a:prstGeom>
              <a:ln w="19080">
                <a:solidFill>
                  <a:srgbClr val="0099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878400" y="3071160"/>
                <a:ext cx="170280" cy="1897920"/>
              </a:xfrm>
              <a:custGeom>
                <a:avLst/>
                <a:gdLst/>
                <a:ahLst/>
                <a:rect l="l" t="t" r="r" b="b"/>
                <a:pathLst>
                  <a:path w="224" h="1488">
                    <a:moveTo>
                      <a:pt x="96" y="0"/>
                    </a:moveTo>
                    <a:cubicBezTo>
                      <a:pt x="136" y="28"/>
                      <a:pt x="176" y="56"/>
                      <a:pt x="192" y="192"/>
                    </a:cubicBezTo>
                    <a:cubicBezTo>
                      <a:pt x="208" y="328"/>
                      <a:pt x="224" y="600"/>
                      <a:pt x="192" y="816"/>
                    </a:cubicBezTo>
                    <a:cubicBezTo>
                      <a:pt x="160" y="1032"/>
                      <a:pt x="32" y="1376"/>
                      <a:pt x="0" y="1488"/>
                    </a:cubicBezTo>
                  </a:path>
                </a:pathLst>
              </a:custGeom>
              <a:solidFill>
                <a:srgbClr val="ccffff"/>
              </a:solidFill>
              <a:ln w="158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915120" y="4664160"/>
                <a:ext cx="109440" cy="304920"/>
              </a:xfrm>
              <a:custGeom>
                <a:avLst/>
                <a:gdLst/>
                <a:ahLst/>
                <a:rect l="l" t="t" r="r" b="b"/>
                <a:pathLst>
                  <a:path w="144" h="240">
                    <a:moveTo>
                      <a:pt x="0" y="240"/>
                    </a:moveTo>
                    <a:cubicBezTo>
                      <a:pt x="36" y="120"/>
                      <a:pt x="72" y="0"/>
                      <a:pt x="96" y="0"/>
                    </a:cubicBezTo>
                    <a:cubicBezTo>
                      <a:pt x="120" y="0"/>
                      <a:pt x="132" y="120"/>
                      <a:pt x="144" y="240"/>
                    </a:cubicBezTo>
                  </a:path>
                </a:pathLst>
              </a:custGeom>
              <a:solidFill>
                <a:srgbClr val="ccffff"/>
              </a:solidFill>
              <a:ln w="158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1134360" y="3071160"/>
                <a:ext cx="182160" cy="1897920"/>
              </a:xfrm>
              <a:custGeom>
                <a:avLst/>
                <a:gdLst/>
                <a:ahLst/>
                <a:rect l="l" t="t" r="r" b="b"/>
                <a:pathLst>
                  <a:path w="240" h="1488">
                    <a:moveTo>
                      <a:pt x="240" y="1488"/>
                    </a:moveTo>
                    <a:cubicBezTo>
                      <a:pt x="164" y="1252"/>
                      <a:pt x="88" y="1016"/>
                      <a:pt x="48" y="768"/>
                    </a:cubicBezTo>
                    <a:cubicBezTo>
                      <a:pt x="8" y="520"/>
                      <a:pt x="8" y="128"/>
                      <a:pt x="0" y="0"/>
                    </a:cubicBezTo>
                  </a:path>
                </a:pathLst>
              </a:custGeom>
              <a:solidFill>
                <a:srgbClr val="ccffff"/>
              </a:solidFill>
              <a:ln w="158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1055160" y="4163400"/>
                <a:ext cx="151560" cy="805680"/>
              </a:xfrm>
              <a:custGeom>
                <a:avLst/>
                <a:gdLst/>
                <a:ahLst/>
                <a:rect l="l" t="t" r="r" b="b"/>
                <a:pathLst>
                  <a:path w="200" h="632">
                    <a:moveTo>
                      <a:pt x="8" y="632"/>
                    </a:moveTo>
                    <a:cubicBezTo>
                      <a:pt x="4" y="512"/>
                      <a:pt x="0" y="392"/>
                      <a:pt x="8" y="296"/>
                    </a:cubicBezTo>
                    <a:cubicBezTo>
                      <a:pt x="16" y="200"/>
                      <a:pt x="24" y="0"/>
                      <a:pt x="56" y="56"/>
                    </a:cubicBezTo>
                    <a:cubicBezTo>
                      <a:pt x="88" y="112"/>
                      <a:pt x="144" y="372"/>
                      <a:pt x="200" y="632"/>
                    </a:cubicBezTo>
                  </a:path>
                </a:pathLst>
              </a:custGeom>
              <a:solidFill>
                <a:srgbClr val="ccffff"/>
              </a:solidFill>
              <a:ln w="158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828000" y="4235400"/>
                <a:ext cx="510840" cy="0"/>
              </a:xfrm>
              <a:prstGeom prst="line">
                <a:avLst/>
              </a:prstGeom>
              <a:ln w="19080">
                <a:solidFill>
                  <a:srgbClr val="0099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828000" y="4664160"/>
                <a:ext cx="510840" cy="0"/>
              </a:xfrm>
              <a:prstGeom prst="line">
                <a:avLst/>
              </a:prstGeom>
              <a:ln w="19080">
                <a:solidFill>
                  <a:srgbClr val="0099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830520" y="490356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r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1107720" y="4903560"/>
                <a:ext cx="349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Oe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767160" y="4453920"/>
                <a:ext cx="307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r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828000" y="4342320"/>
                <a:ext cx="510840" cy="0"/>
              </a:xfrm>
              <a:prstGeom prst="line">
                <a:avLst/>
              </a:prstGeom>
              <a:ln w="19080">
                <a:solidFill>
                  <a:srgbClr val="0099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828000" y="4758120"/>
                <a:ext cx="510840" cy="0"/>
              </a:xfrm>
              <a:prstGeom prst="line">
                <a:avLst/>
              </a:prstGeom>
              <a:ln w="19080">
                <a:solidFill>
                  <a:srgbClr val="0099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828000" y="4449240"/>
                <a:ext cx="510840" cy="0"/>
              </a:xfrm>
              <a:prstGeom prst="line">
                <a:avLst/>
              </a:prstGeom>
              <a:ln w="19080">
                <a:solidFill>
                  <a:srgbClr val="0099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829440" y="3805200"/>
                <a:ext cx="336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o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828000" y="3657240"/>
                <a:ext cx="510840" cy="0"/>
              </a:xfrm>
              <a:prstGeom prst="line">
                <a:avLst/>
              </a:prstGeom>
              <a:ln w="19080">
                <a:solidFill>
                  <a:srgbClr val="0099cc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1304640" y="2987280"/>
                <a:ext cx="32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1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1304640" y="3550320"/>
                <a:ext cx="32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2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1304640" y="4114080"/>
                <a:ext cx="32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3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1304640" y="4245480"/>
                <a:ext cx="32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4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1304640" y="4375440"/>
                <a:ext cx="32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5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1304640" y="4534200"/>
                <a:ext cx="32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6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1304640" y="4665240"/>
                <a:ext cx="328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7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777960" y="2816280"/>
                <a:ext cx="6469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11.5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200" name=""/>
            <p:cNvGrpSpPr/>
            <p:nvPr/>
          </p:nvGrpSpPr>
          <p:grpSpPr>
            <a:xfrm>
              <a:off x="1676520" y="606240"/>
              <a:ext cx="779400" cy="928800"/>
              <a:chOff x="1676520" y="606240"/>
              <a:chExt cx="779400" cy="928800"/>
            </a:xfrm>
          </p:grpSpPr>
          <p:pic>
            <p:nvPicPr>
              <p:cNvPr id="201" name="" descr=""/>
              <p:cNvPicPr/>
              <p:nvPr/>
            </p:nvPicPr>
            <p:blipFill>
              <a:blip r:embed="rId2">
                <a:lum bright="-6000"/>
              </a:blip>
              <a:srcRect l="31862" t="7373" r="22114" b="37897"/>
              <a:stretch/>
            </p:blipFill>
            <p:spPr>
              <a:xfrm>
                <a:off x="1676520" y="606240"/>
                <a:ext cx="779400" cy="928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2" name=""/>
              <p:cNvSpPr/>
              <p:nvPr/>
            </p:nvSpPr>
            <p:spPr>
              <a:xfrm>
                <a:off x="1768680" y="1109880"/>
                <a:ext cx="54576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03" name=""/>
            <p:cNvSpPr/>
            <p:nvPr/>
          </p:nvSpPr>
          <p:spPr>
            <a:xfrm>
              <a:off x="1895400" y="4092480"/>
              <a:ext cx="506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1895400" y="4957560"/>
              <a:ext cx="506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1895400" y="4525920"/>
              <a:ext cx="506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1895400" y="4308480"/>
              <a:ext cx="506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2401920" y="4092480"/>
              <a:ext cx="0" cy="865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08" name=""/>
            <p:cNvGrpSpPr/>
            <p:nvPr/>
          </p:nvGrpSpPr>
          <p:grpSpPr>
            <a:xfrm>
              <a:off x="1661400" y="1582560"/>
              <a:ext cx="803520" cy="1008360"/>
              <a:chOff x="1661400" y="1582560"/>
              <a:chExt cx="803520" cy="1008360"/>
            </a:xfrm>
          </p:grpSpPr>
          <p:pic>
            <p:nvPicPr>
              <p:cNvPr id="209" name="" descr=""/>
              <p:cNvPicPr/>
              <p:nvPr/>
            </p:nvPicPr>
            <p:blipFill>
              <a:blip r:embed="rId3"/>
              <a:srcRect l="17539" t="11580" r="25551" b="29471"/>
              <a:stretch/>
            </p:blipFill>
            <p:spPr>
              <a:xfrm>
                <a:off x="1689480" y="1582560"/>
                <a:ext cx="775440" cy="928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0" name=""/>
              <p:cNvSpPr/>
              <p:nvPr/>
            </p:nvSpPr>
            <p:spPr>
              <a:xfrm flipV="1">
                <a:off x="1725120" y="1932480"/>
                <a:ext cx="631800" cy="2469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1661400" y="2283840"/>
                <a:ext cx="378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b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212" name=""/>
            <p:cNvGrpSpPr/>
            <p:nvPr/>
          </p:nvGrpSpPr>
          <p:grpSpPr>
            <a:xfrm>
              <a:off x="1665360" y="2987640"/>
              <a:ext cx="825480" cy="1051200"/>
              <a:chOff x="1665360" y="2987640"/>
              <a:chExt cx="825480" cy="1051200"/>
            </a:xfrm>
          </p:grpSpPr>
          <p:pic>
            <p:nvPicPr>
              <p:cNvPr id="213" name="" descr=""/>
              <p:cNvPicPr/>
              <p:nvPr/>
            </p:nvPicPr>
            <p:blipFill>
              <a:blip r:embed="rId4"/>
              <a:srcRect l="31600" t="16800" r="35547" b="23262"/>
              <a:stretch/>
            </p:blipFill>
            <p:spPr>
              <a:xfrm>
                <a:off x="1665360" y="2987640"/>
                <a:ext cx="825480" cy="1006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4" name=""/>
              <p:cNvSpPr/>
              <p:nvPr/>
            </p:nvSpPr>
            <p:spPr>
              <a:xfrm>
                <a:off x="1820520" y="3517920"/>
                <a:ext cx="50616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2094480" y="3731760"/>
                <a:ext cx="330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t</a:t>
                </a:r>
                <a:endParaRPr b="0" lang="en-US" sz="1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16" name=""/>
            <p:cNvSpPr/>
            <p:nvPr/>
          </p:nvSpPr>
          <p:spPr>
            <a:xfrm>
              <a:off x="1641600" y="5461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1641600" y="15415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aphicFrame>
          <p:nvGraphicFramePr>
            <p:cNvPr id="218" name=""/>
            <p:cNvGraphicFramePr/>
            <p:nvPr/>
          </p:nvGraphicFramePr>
          <p:xfrm>
            <a:off x="2951280" y="741240"/>
            <a:ext cx="2724120" cy="202572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219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2951280" y="741240"/>
                      <a:ext cx="2724120" cy="2025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20" name=""/>
            <p:cNvSpPr/>
            <p:nvPr/>
          </p:nvSpPr>
          <p:spPr>
            <a:xfrm>
              <a:off x="4448160" y="974520"/>
              <a:ext cx="252360" cy="1238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448160" y="1160280"/>
              <a:ext cx="252360" cy="122400"/>
            </a:xfrm>
            <a:prstGeom prst="rect">
              <a:avLst/>
            </a:prstGeom>
            <a:solidFill>
              <a:srgbClr val="0000ff"/>
            </a:solidFill>
            <a:ln w="936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4700520" y="884160"/>
              <a:ext cx="665280" cy="58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3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rsal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35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Ventral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056840" y="2708280"/>
              <a:ext cx="123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vel of foregu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2999160" y="48888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1641600" y="294156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1646280" y="399420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aphicFrame>
          <p:nvGraphicFramePr>
            <p:cNvPr id="227" name=""/>
            <p:cNvGraphicFramePr/>
            <p:nvPr/>
          </p:nvGraphicFramePr>
          <p:xfrm>
            <a:off x="2951280" y="3124080"/>
            <a:ext cx="2751120" cy="170820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228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2951280" y="3124080"/>
                      <a:ext cx="2751120" cy="1708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29" name=""/>
            <p:cNvSpPr/>
            <p:nvPr/>
          </p:nvSpPr>
          <p:spPr>
            <a:xfrm>
              <a:off x="4357800" y="3294000"/>
              <a:ext cx="0" cy="1285920"/>
            </a:xfrm>
            <a:prstGeom prst="line">
              <a:avLst/>
            </a:prstGeom>
            <a:ln w="6480">
              <a:solidFill>
                <a:srgbClr val="6600cc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3647160" y="3225600"/>
              <a:ext cx="741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ndivided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368240" y="3225600"/>
              <a:ext cx="60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vided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2993760" y="2878200"/>
              <a:ext cx="320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aphicFrame>
          <p:nvGraphicFramePr>
            <p:cNvPr id="233" name=""/>
            <p:cNvGraphicFramePr/>
            <p:nvPr/>
          </p:nvGraphicFramePr>
          <p:xfrm>
            <a:off x="1006560" y="5665680"/>
            <a:ext cx="2276280" cy="161604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234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1006560" y="5665680"/>
                      <a:ext cx="2276280" cy="1616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235" name=""/>
            <p:cNvGrpSpPr/>
            <p:nvPr/>
          </p:nvGrpSpPr>
          <p:grpSpPr>
            <a:xfrm>
              <a:off x="1246320" y="5475240"/>
              <a:ext cx="1170000" cy="550800"/>
              <a:chOff x="1246320" y="5475240"/>
              <a:chExt cx="1170000" cy="550800"/>
            </a:xfrm>
          </p:grpSpPr>
          <p:sp>
            <p:nvSpPr>
              <p:cNvPr id="236" name=""/>
              <p:cNvSpPr/>
              <p:nvPr/>
            </p:nvSpPr>
            <p:spPr>
              <a:xfrm>
                <a:off x="1319760" y="5475240"/>
                <a:ext cx="1096560" cy="550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orsalmost (Ds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ddle (M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ntral (V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237" name=""/>
              <p:cNvGrpSpPr/>
              <p:nvPr/>
            </p:nvGrpSpPr>
            <p:grpSpPr>
              <a:xfrm>
                <a:off x="1246320" y="5556240"/>
                <a:ext cx="119880" cy="297360"/>
                <a:chOff x="1246320" y="5556240"/>
                <a:chExt cx="119880" cy="297360"/>
              </a:xfrm>
            </p:grpSpPr>
            <p:sp>
              <p:nvSpPr>
                <p:cNvPr id="238" name=""/>
                <p:cNvSpPr/>
                <p:nvPr/>
              </p:nvSpPr>
              <p:spPr>
                <a:xfrm>
                  <a:off x="1246320" y="5556240"/>
                  <a:ext cx="119880" cy="64440"/>
                </a:xfrm>
                <a:prstGeom prst="rect">
                  <a:avLst/>
                </a:prstGeom>
                <a:solidFill>
                  <a:srgbClr val="ffff80"/>
                </a:solidFill>
                <a:ln w="9360">
                  <a:solidFill>
                    <a:srgbClr val="ffff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17640" bIns="1764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39" name=""/>
                <p:cNvSpPr/>
                <p:nvPr/>
              </p:nvSpPr>
              <p:spPr>
                <a:xfrm>
                  <a:off x="1246320" y="5667120"/>
                  <a:ext cx="119880" cy="64080"/>
                </a:xfrm>
                <a:prstGeom prst="rect">
                  <a:avLst/>
                </a:prstGeom>
                <a:solidFill>
                  <a:srgbClr val="93f7f7"/>
                </a:solidFill>
                <a:ln w="9360">
                  <a:solidFill>
                    <a:srgbClr val="93f7f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17280" bIns="1728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40" name=""/>
                <p:cNvSpPr/>
                <p:nvPr/>
              </p:nvSpPr>
              <p:spPr>
                <a:xfrm>
                  <a:off x="1246320" y="5789520"/>
                  <a:ext cx="119880" cy="64080"/>
                </a:xfrm>
                <a:prstGeom prst="rect">
                  <a:avLst/>
                </a:prstGeom>
                <a:solidFill>
                  <a:srgbClr val="0000ff"/>
                </a:solidFill>
                <a:ln w="936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17280" bIns="1728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241" name=""/>
            <p:cNvSpPr/>
            <p:nvPr/>
          </p:nvSpPr>
          <p:spPr>
            <a:xfrm>
              <a:off x="982440" y="5241960"/>
              <a:ext cx="358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aphicFrame>
          <p:nvGraphicFramePr>
            <p:cNvPr id="242" name=""/>
            <p:cNvGraphicFramePr/>
            <p:nvPr/>
          </p:nvGraphicFramePr>
          <p:xfrm>
            <a:off x="3639960" y="5686560"/>
            <a:ext cx="2275200" cy="1535040"/>
          </p:xfrm>
          <a:graphic>
            <a:graphicData uri="http://schemas.openxmlformats.org/presentationml/2006/ole">
              <p:oleObj r:id="rId11" spid="">
                <p:embed/>
                <p:pic>
                  <p:nvPicPr>
                    <p:cNvPr id="243" name="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3639960" y="5686560"/>
                      <a:ext cx="2275200" cy="1535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244" name=""/>
            <p:cNvGrpSpPr/>
            <p:nvPr/>
          </p:nvGrpSpPr>
          <p:grpSpPr>
            <a:xfrm>
              <a:off x="3879720" y="5475240"/>
              <a:ext cx="1170000" cy="550800"/>
              <a:chOff x="3879720" y="5475240"/>
              <a:chExt cx="1170000" cy="550800"/>
            </a:xfrm>
          </p:grpSpPr>
          <p:sp>
            <p:nvSpPr>
              <p:cNvPr id="245" name=""/>
              <p:cNvSpPr/>
              <p:nvPr/>
            </p:nvSpPr>
            <p:spPr>
              <a:xfrm>
                <a:off x="3953160" y="5475240"/>
                <a:ext cx="1096560" cy="550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orsalmost (Ds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ddle (M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ntral (V)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246" name=""/>
              <p:cNvGrpSpPr/>
              <p:nvPr/>
            </p:nvGrpSpPr>
            <p:grpSpPr>
              <a:xfrm>
                <a:off x="3879720" y="5556240"/>
                <a:ext cx="119880" cy="297360"/>
                <a:chOff x="3879720" y="5556240"/>
                <a:chExt cx="119880" cy="297360"/>
              </a:xfrm>
            </p:grpSpPr>
            <p:sp>
              <p:nvSpPr>
                <p:cNvPr id="247" name=""/>
                <p:cNvSpPr/>
                <p:nvPr/>
              </p:nvSpPr>
              <p:spPr>
                <a:xfrm>
                  <a:off x="3879720" y="5556240"/>
                  <a:ext cx="119880" cy="64440"/>
                </a:xfrm>
                <a:prstGeom prst="rect">
                  <a:avLst/>
                </a:prstGeom>
                <a:solidFill>
                  <a:srgbClr val="ffff80"/>
                </a:solidFill>
                <a:ln w="9360">
                  <a:solidFill>
                    <a:srgbClr val="ffff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17640" bIns="1764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48" name=""/>
                <p:cNvSpPr/>
                <p:nvPr/>
              </p:nvSpPr>
              <p:spPr>
                <a:xfrm>
                  <a:off x="3879720" y="5667120"/>
                  <a:ext cx="119880" cy="64080"/>
                </a:xfrm>
                <a:prstGeom prst="rect">
                  <a:avLst/>
                </a:prstGeom>
                <a:solidFill>
                  <a:srgbClr val="93f7f7"/>
                </a:solidFill>
                <a:ln w="9360">
                  <a:solidFill>
                    <a:srgbClr val="93f7f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17280" bIns="1728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49" name=""/>
                <p:cNvSpPr/>
                <p:nvPr/>
              </p:nvSpPr>
              <p:spPr>
                <a:xfrm>
                  <a:off x="3879720" y="5789520"/>
                  <a:ext cx="119880" cy="64080"/>
                </a:xfrm>
                <a:prstGeom prst="rect">
                  <a:avLst/>
                </a:prstGeom>
                <a:solidFill>
                  <a:srgbClr val="0000ff"/>
                </a:solidFill>
                <a:ln w="936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17280" bIns="1728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250" name=""/>
            <p:cNvSpPr/>
            <p:nvPr/>
          </p:nvSpPr>
          <p:spPr>
            <a:xfrm>
              <a:off x="3646800" y="524196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</a:t>
              </a:r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1" name=""/>
            <p:cNvSpPr/>
            <p:nvPr/>
          </p:nvSpPr>
          <p:spPr>
            <a:xfrm rot="16200000">
              <a:off x="124560" y="6080760"/>
              <a:ext cx="1645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pithelial mitotic index (%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2" name=""/>
            <p:cNvSpPr/>
            <p:nvPr/>
          </p:nvSpPr>
          <p:spPr>
            <a:xfrm rot="16200000">
              <a:off x="2586960" y="6087240"/>
              <a:ext cx="193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esenchymal mitotic index (%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2233440" y="1511280"/>
              <a:ext cx="2098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3548160" y="2495520"/>
              <a:ext cx="379440" cy="0"/>
            </a:xfrm>
            <a:prstGeom prst="line">
              <a:avLst/>
            </a:prstGeom>
            <a:ln w="12600">
              <a:solidFill>
                <a:srgbClr val="0099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4097160" y="2495520"/>
              <a:ext cx="379440" cy="0"/>
            </a:xfrm>
            <a:prstGeom prst="line">
              <a:avLst/>
            </a:prstGeom>
            <a:ln w="12600">
              <a:solidFill>
                <a:srgbClr val="0099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4645080" y="2495520"/>
              <a:ext cx="380880" cy="0"/>
            </a:xfrm>
            <a:prstGeom prst="line">
              <a:avLst/>
            </a:prstGeom>
            <a:ln w="12600">
              <a:solidFill>
                <a:srgbClr val="0099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5194440" y="2495520"/>
              <a:ext cx="379440" cy="0"/>
            </a:xfrm>
            <a:prstGeom prst="line">
              <a:avLst/>
            </a:prstGeom>
            <a:ln w="12600">
              <a:solidFill>
                <a:srgbClr val="0099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3281400" y="2415960"/>
              <a:ext cx="2512800" cy="292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3317760" y="2481120"/>
              <a:ext cx="2351160" cy="1800"/>
            </a:xfrm>
            <a:custGeom>
              <a:avLst/>
              <a:gdLst/>
              <a:ahLst/>
              <a:rect l="l" t="t" r="r" b="b"/>
              <a:pathLst>
                <a:path w="1782" h="2">
                  <a:moveTo>
                    <a:pt x="0" y="0"/>
                  </a:moveTo>
                  <a:lnTo>
                    <a:pt x="1782" y="2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3527280" y="2525760"/>
              <a:ext cx="416160" cy="1440"/>
            </a:xfrm>
            <a:custGeom>
              <a:avLst/>
              <a:gdLst/>
              <a:ahLst/>
              <a:rect l="l" t="t" r="r" b="b"/>
              <a:pathLst>
                <a:path w="315" h="1">
                  <a:moveTo>
                    <a:pt x="0" y="0"/>
                  </a:moveTo>
                  <a:lnTo>
                    <a:pt x="315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4049640" y="2521080"/>
              <a:ext cx="433440" cy="2880"/>
            </a:xfrm>
            <a:custGeom>
              <a:avLst/>
              <a:gdLst/>
              <a:ahLst/>
              <a:rect l="l" t="t" r="r" b="b"/>
              <a:pathLst>
                <a:path w="273" h="2">
                  <a:moveTo>
                    <a:pt x="0" y="0"/>
                  </a:moveTo>
                  <a:lnTo>
                    <a:pt x="273" y="2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4603680" y="2521080"/>
              <a:ext cx="412920" cy="4680"/>
            </a:xfrm>
            <a:custGeom>
              <a:avLst/>
              <a:gdLst/>
              <a:ahLst/>
              <a:rect l="l" t="t" r="r" b="b"/>
              <a:pathLst>
                <a:path w="312" h="3">
                  <a:moveTo>
                    <a:pt x="0" y="0"/>
                  </a:moveTo>
                  <a:lnTo>
                    <a:pt x="312" y="3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5165640" y="2525760"/>
              <a:ext cx="420840" cy="1440"/>
            </a:xfrm>
            <a:custGeom>
              <a:avLst/>
              <a:gdLst/>
              <a:ahLst/>
              <a:rect l="l" t="t" r="r" b="b"/>
              <a:pathLst>
                <a:path w="318" h="1">
                  <a:moveTo>
                    <a:pt x="0" y="0"/>
                  </a:moveTo>
                  <a:lnTo>
                    <a:pt x="318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3641760" y="253368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4179960" y="253368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4712040" y="253368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5251680" y="253368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3317760" y="2403360"/>
              <a:ext cx="1800" cy="79560"/>
            </a:xfrm>
            <a:custGeom>
              <a:avLst/>
              <a:gdLst/>
              <a:ahLst/>
              <a:rect l="l" t="t" r="r" b="b"/>
              <a:pathLst>
                <a:path w="1" h="62">
                  <a:moveTo>
                    <a:pt x="0" y="62"/>
                  </a:moveTo>
                  <a:lnTo>
                    <a:pt x="0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4056840" y="4927680"/>
              <a:ext cx="123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vel of foregu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70" name=""/>
            <p:cNvGrpSpPr/>
            <p:nvPr/>
          </p:nvGrpSpPr>
          <p:grpSpPr>
            <a:xfrm>
              <a:off x="3222720" y="4637160"/>
              <a:ext cx="2513520" cy="331200"/>
              <a:chOff x="3222720" y="4637160"/>
              <a:chExt cx="2513520" cy="331200"/>
            </a:xfrm>
          </p:grpSpPr>
          <p:sp>
            <p:nvSpPr>
              <p:cNvPr id="271" name=""/>
              <p:cNvSpPr/>
              <p:nvPr/>
            </p:nvSpPr>
            <p:spPr>
              <a:xfrm>
                <a:off x="3222720" y="4694760"/>
                <a:ext cx="2511720" cy="2322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 flipV="1">
                <a:off x="3281760" y="4637160"/>
                <a:ext cx="2445840" cy="59040"/>
              </a:xfrm>
              <a:custGeom>
                <a:avLst/>
                <a:gdLst/>
                <a:ahLst/>
                <a:rect l="l" t="t" r="r" b="b"/>
                <a:pathLst>
                  <a:path w="1788" h="1">
                    <a:moveTo>
                      <a:pt x="0" y="0"/>
                    </a:moveTo>
                    <a:lnTo>
                      <a:pt x="1788" y="0"/>
                    </a:lnTo>
                  </a:path>
                </a:pathLst>
              </a:custGeom>
              <a:noFill/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273" name=""/>
              <p:cNvGrpSpPr/>
              <p:nvPr/>
            </p:nvGrpSpPr>
            <p:grpSpPr>
              <a:xfrm>
                <a:off x="3402000" y="4747680"/>
                <a:ext cx="2264760" cy="4680"/>
                <a:chOff x="3402000" y="4747680"/>
                <a:chExt cx="2264760" cy="4680"/>
              </a:xfrm>
            </p:grpSpPr>
            <p:sp>
              <p:nvSpPr>
                <p:cNvPr id="274" name=""/>
                <p:cNvSpPr/>
                <p:nvPr/>
              </p:nvSpPr>
              <p:spPr>
                <a:xfrm>
                  <a:off x="3402000" y="4751280"/>
                  <a:ext cx="231840" cy="1080"/>
                </a:xfrm>
                <a:custGeom>
                  <a:avLst/>
                  <a:gdLst/>
                  <a:ahLst/>
                  <a:rect l="l" t="t" r="r" b="b"/>
                  <a:pathLst>
                    <a:path w="176" h="1">
                      <a:moveTo>
                        <a:pt x="0" y="0"/>
                      </a:moveTo>
                      <a:lnTo>
                        <a:pt x="176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75" name=""/>
                <p:cNvSpPr/>
                <p:nvPr/>
              </p:nvSpPr>
              <p:spPr>
                <a:xfrm>
                  <a:off x="4088880" y="4747680"/>
                  <a:ext cx="210960" cy="1080"/>
                </a:xfrm>
                <a:custGeom>
                  <a:avLst/>
                  <a:gdLst/>
                  <a:ahLst/>
                  <a:rect l="l" t="t" r="r" b="b"/>
                  <a:pathLst>
                    <a:path w="160" h="1">
                      <a:moveTo>
                        <a:pt x="0" y="1"/>
                      </a:moveTo>
                      <a:lnTo>
                        <a:pt x="160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76" name=""/>
                <p:cNvSpPr/>
                <p:nvPr/>
              </p:nvSpPr>
              <p:spPr>
                <a:xfrm>
                  <a:off x="4748040" y="4748760"/>
                  <a:ext cx="237240" cy="1080"/>
                </a:xfrm>
                <a:custGeom>
                  <a:avLst/>
                  <a:gdLst/>
                  <a:ahLst/>
                  <a:rect l="l" t="t" r="r" b="b"/>
                  <a:pathLst>
                    <a:path w="180" h="1">
                      <a:moveTo>
                        <a:pt x="0" y="0"/>
                      </a:moveTo>
                      <a:lnTo>
                        <a:pt x="180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77" name=""/>
                <p:cNvSpPr/>
                <p:nvPr/>
              </p:nvSpPr>
              <p:spPr>
                <a:xfrm>
                  <a:off x="5434920" y="4751280"/>
                  <a:ext cx="231840" cy="1080"/>
                </a:xfrm>
                <a:custGeom>
                  <a:avLst/>
                  <a:gdLst/>
                  <a:ahLst/>
                  <a:rect l="l" t="t" r="r" b="b"/>
                  <a:pathLst>
                    <a:path w="176" h="1">
                      <a:moveTo>
                        <a:pt x="0" y="0"/>
                      </a:moveTo>
                      <a:lnTo>
                        <a:pt x="176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78" name=""/>
                <p:cNvSpPr/>
                <p:nvPr/>
              </p:nvSpPr>
              <p:spPr>
                <a:xfrm>
                  <a:off x="3760200" y="4751280"/>
                  <a:ext cx="221400" cy="1080"/>
                </a:xfrm>
                <a:custGeom>
                  <a:avLst/>
                  <a:gdLst/>
                  <a:ahLst/>
                  <a:rect l="l" t="t" r="r" b="b"/>
                  <a:pathLst>
                    <a:path w="168" h="1">
                      <a:moveTo>
                        <a:pt x="0" y="0"/>
                      </a:moveTo>
                      <a:lnTo>
                        <a:pt x="168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79" name=""/>
                <p:cNvSpPr/>
                <p:nvPr/>
              </p:nvSpPr>
              <p:spPr>
                <a:xfrm>
                  <a:off x="4418280" y="4749840"/>
                  <a:ext cx="221400" cy="1080"/>
                </a:xfrm>
                <a:custGeom>
                  <a:avLst/>
                  <a:gdLst/>
                  <a:ahLst/>
                  <a:rect l="l" t="t" r="r" b="b"/>
                  <a:pathLst>
                    <a:path w="168" h="1">
                      <a:moveTo>
                        <a:pt x="0" y="0"/>
                      </a:moveTo>
                      <a:lnTo>
                        <a:pt x="168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80" name=""/>
                <p:cNvSpPr/>
                <p:nvPr/>
              </p:nvSpPr>
              <p:spPr>
                <a:xfrm>
                  <a:off x="5076360" y="4751280"/>
                  <a:ext cx="237240" cy="1080"/>
                </a:xfrm>
                <a:custGeom>
                  <a:avLst/>
                  <a:gdLst/>
                  <a:ahLst/>
                  <a:rect l="l" t="t" r="r" b="b"/>
                  <a:pathLst>
                    <a:path w="180" h="1">
                      <a:moveTo>
                        <a:pt x="0" y="0"/>
                      </a:moveTo>
                      <a:lnTo>
                        <a:pt x="180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281" name=""/>
              <p:cNvGrpSpPr/>
              <p:nvPr/>
            </p:nvGrpSpPr>
            <p:grpSpPr>
              <a:xfrm>
                <a:off x="3403800" y="4752720"/>
                <a:ext cx="2332440" cy="215640"/>
                <a:chOff x="3403800" y="4752720"/>
                <a:chExt cx="2332440" cy="215640"/>
              </a:xfrm>
            </p:grpSpPr>
            <p:sp>
              <p:nvSpPr>
                <p:cNvPr id="282" name=""/>
                <p:cNvSpPr/>
                <p:nvPr/>
              </p:nvSpPr>
              <p:spPr>
                <a:xfrm>
                  <a:off x="3403800" y="475272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1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83" name=""/>
                <p:cNvSpPr/>
                <p:nvPr/>
              </p:nvSpPr>
              <p:spPr>
                <a:xfrm>
                  <a:off x="3762000" y="475272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2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84" name=""/>
                <p:cNvSpPr/>
                <p:nvPr/>
              </p:nvSpPr>
              <p:spPr>
                <a:xfrm>
                  <a:off x="4062600" y="475272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3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85" name=""/>
                <p:cNvSpPr/>
                <p:nvPr/>
              </p:nvSpPr>
              <p:spPr>
                <a:xfrm>
                  <a:off x="5436720" y="475272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7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86" name=""/>
                <p:cNvSpPr/>
                <p:nvPr/>
              </p:nvSpPr>
              <p:spPr>
                <a:xfrm>
                  <a:off x="4420080" y="475272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4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87" name=""/>
                <p:cNvSpPr/>
                <p:nvPr/>
              </p:nvSpPr>
              <p:spPr>
                <a:xfrm>
                  <a:off x="4719240" y="475272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5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88" name=""/>
                <p:cNvSpPr/>
                <p:nvPr/>
              </p:nvSpPr>
              <p:spPr>
                <a:xfrm>
                  <a:off x="5078160" y="4752720"/>
                  <a:ext cx="2995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6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289" name=""/>
            <p:cNvSpPr/>
            <p:nvPr/>
          </p:nvSpPr>
          <p:spPr>
            <a:xfrm>
              <a:off x="1782000" y="7321680"/>
              <a:ext cx="123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vel of foregu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947880" y="7089840"/>
              <a:ext cx="2512800" cy="231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1149480" y="7089840"/>
              <a:ext cx="2174760" cy="1440"/>
            </a:xfrm>
            <a:custGeom>
              <a:avLst/>
              <a:gdLst/>
              <a:ahLst/>
              <a:rect l="l" t="t" r="r" b="b"/>
              <a:pathLst>
                <a:path w="1648" h="1">
                  <a:moveTo>
                    <a:pt x="0" y="0"/>
                  </a:moveTo>
                  <a:lnTo>
                    <a:pt x="1648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2347920" y="7146720"/>
              <a:ext cx="849240" cy="1800"/>
            </a:xfrm>
            <a:custGeom>
              <a:avLst/>
              <a:gdLst/>
              <a:ahLst/>
              <a:rect l="l" t="t" r="r" b="b"/>
              <a:pathLst>
                <a:path w="644" h="1">
                  <a:moveTo>
                    <a:pt x="0" y="0"/>
                  </a:moveTo>
                  <a:lnTo>
                    <a:pt x="644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1365120" y="7146720"/>
              <a:ext cx="838440" cy="59040"/>
            </a:xfrm>
            <a:custGeom>
              <a:avLst/>
              <a:gdLst/>
              <a:ahLst/>
              <a:rect l="l" t="t" r="r" b="b"/>
              <a:pathLst>
                <a:path w="168" h="1">
                  <a:moveTo>
                    <a:pt x="0" y="0"/>
                  </a:moveTo>
                  <a:lnTo>
                    <a:pt x="168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1667160" y="714672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2684520" y="714672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4415400" y="7321680"/>
              <a:ext cx="123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vel of foregut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3581280" y="7089840"/>
              <a:ext cx="2513160" cy="231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3798720" y="7089840"/>
              <a:ext cx="2159280" cy="1440"/>
            </a:xfrm>
            <a:custGeom>
              <a:avLst/>
              <a:gdLst/>
              <a:ahLst/>
              <a:rect l="l" t="t" r="r" b="b"/>
              <a:pathLst>
                <a:path w="1636" h="1">
                  <a:moveTo>
                    <a:pt x="0" y="0"/>
                  </a:moveTo>
                  <a:lnTo>
                    <a:pt x="1636" y="0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4981680" y="7146720"/>
              <a:ext cx="849240" cy="1800"/>
            </a:xfrm>
            <a:custGeom>
              <a:avLst/>
              <a:gdLst/>
              <a:ahLst/>
              <a:rect l="l" t="t" r="r" b="b"/>
              <a:pathLst>
                <a:path w="644" h="1">
                  <a:moveTo>
                    <a:pt x="0" y="0"/>
                  </a:moveTo>
                  <a:lnTo>
                    <a:pt x="644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3998880" y="7146720"/>
              <a:ext cx="838080" cy="59040"/>
            </a:xfrm>
            <a:custGeom>
              <a:avLst/>
              <a:gdLst/>
              <a:ahLst/>
              <a:rect l="l" t="t" r="r" b="b"/>
              <a:pathLst>
                <a:path w="168" h="1">
                  <a:moveTo>
                    <a:pt x="0" y="0"/>
                  </a:moveTo>
                  <a:lnTo>
                    <a:pt x="168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4300920" y="714672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5318280" y="714672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L3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03" name=""/>
          <p:cNvSpPr/>
          <p:nvPr/>
        </p:nvSpPr>
        <p:spPr>
          <a:xfrm>
            <a:off x="260280" y="7832880"/>
            <a:ext cx="640872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Supplementary Fig. 3 – Cell proliferation during tracheo-oesophageal separatio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(A,B,D,E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Immunohistochemistry for the mitotic marker phosphohistone H3 on transverse sections from E10.5 (A,B) and E11.5 (D,E) CBA/Ca embryos, at levels indicated on the schematic representations (A:L3, B:L4, D:L1, E:L3). Lines drawn on sections define dorso-ventral epithelial and mesenchymal zones for cell proliferation analysis. (E) Middle and mesenchymal zones were analysed only at L2 and L3 at E11.5.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</a:rPr>
              <a:t>(C,F,G,H)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Box plots showing mitotic indices for the different dorso-ventral zones at E10.5 (C,G) and E11.5 (F,H). At E11.5, both ventral and dorsal zones at L1 and L2, where the foregut is undivided, have significantly lower H3-indices than at L6 and L7, where separation is complete (F;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&lt; 0.02). Abbreviations as in Fig. 3. Scale bar (in A): 50 μm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3-18T14:34:06Z</dcterms:created>
  <dc:creator>IT Department</dc:creator>
  <dc:description/>
  <dc:language>en-US</dc:language>
  <cp:lastModifiedBy>Andrew Copp</cp:lastModifiedBy>
  <cp:lastPrinted>2008-03-13T17:22:02Z</cp:lastPrinted>
  <dcterms:modified xsi:type="dcterms:W3CDTF">2009-09-25T11:53:12Z</dcterms:modified>
  <cp:revision>433</cp:revision>
  <dc:subject/>
  <dc:title>PowerPoint Presentation</dc:title>
</cp:coreProperties>
</file>